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645877-5F97-8242-A292-413B52B5DC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10A81F0-85D7-FC49-B742-70A866A4AA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8CF876F-E00F-1D4A-AAD7-D5905A0A1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FDA55F8-7E57-0642-A046-6DC1B3BB3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03A606A-BCB2-B744-A97C-8DEEC19A2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91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4CDD9BA-8033-CD41-BBA3-3AF29B94F5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BE25F31-6FF0-574B-B24A-AFB8258F2E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24BB207-5527-B740-BF73-086B689B2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74BB481-ACD1-374F-A754-3CE30751A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04503F3-F737-E440-91F8-58E794318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7437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3F3BED5-DC12-054E-9D8E-7C835D220A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018C05F-3666-664D-86C5-F1A684B167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211908C-ABF1-D645-A20C-20304ADF5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7FD2BEC-C4A7-0A47-92CE-B677DEE44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D409E8-FF5D-B84C-ADA6-B80BBBA81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3295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E9A3574-66EB-5842-A59F-9918461561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689115E-951C-6848-A675-98EABE71A2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8BD0F38-9F03-2C40-B3B9-B829B7735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5AB5FA6-D064-B547-A280-F49659089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DA80720-2953-BE4B-A6E6-A061827C2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1385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6C600BD-D971-8949-A48B-D5436D442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B8F1510-85D7-2544-8E74-896D41090A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10FDE45-CB2D-9340-899F-CA5881E9E8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77432B-3900-2E4F-94C7-C5C18CD83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7295EB3-C34F-0D42-831F-0E19E742E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3161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52F825A-A1A5-1C4D-8C29-B5F0BF7802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BB42EE7-F8DD-874E-9FF9-E8A91E34A0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3556C4E-A0D5-084F-AAB2-2ED2F0BE59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AF6F607-EDB6-E243-BC4A-23F0E588C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BEBE8AD-86ED-4F42-B62F-BB633066D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EE24DEF-AB81-9649-BEAD-2CEC93758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711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05EA11B-2DAC-0642-8AE4-5221BB4898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94FB003-5676-1441-84B7-0D30026EF7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92727DD-6877-654C-A46E-638CCF4DEF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B0B31ED-C9DC-0549-8160-480032CAD5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E4C8A8F5-C184-0047-B8E0-EFE4E46FDC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675DD4B-78D0-804A-BF6E-7312C6CF4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A5DE486-A0C1-794F-BAB3-17BA3400E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20F0CB5-393A-DB4C-921F-E5A1827898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207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1756CC8-829D-3740-B8BD-4F8193A713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91A938A-3F19-8D44-84FB-9DDFD5A88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8736D75-8FC1-1641-836D-60E2B21B24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02D7EA7E-1C70-2440-91D4-C7A37E163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144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F69CB64-3593-394F-B5EA-EA3A492EF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264AB901-6BEB-F947-A9E3-6CAD7777B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C7640538-6F84-614C-9A10-5D5FB281A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4193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1026FC0-B76B-2A43-B5A3-2FFC8E5A30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E388E8B-F91C-274B-BAD0-1E3559CD55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5B00E32-9A9E-A544-9721-6295D5625D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C40A1EF-FB3D-934D-ACAE-B48E11024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AEE6168-8E63-A844-B4D1-85652F7E3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0B92B0-15F1-0B4E-8D01-BAC407A95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7935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7A419F-A6F8-2B4A-B097-0E6D592126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A6AD158-9CB4-C64E-94B0-01C33B139E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38A05AE-EAC3-DF43-A6DC-1DFAFABAEB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7B40876-BB7D-2C4F-936D-4982F658E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BFA8DFC-223C-B048-A996-58247B18B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AF7F83E-707F-B24D-ABFD-A43634E20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7492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3087A80-2CE9-D946-BAB6-ACB98A486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FD6B714-F4C3-1046-92FC-B1DEA34898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A5972AB-F29C-9F46-B034-366A7902DA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6B79D-EC96-3644-90C5-983D2ED5FE0D}" type="datetimeFigureOut">
              <a:rPr lang="fr-FR" smtClean="0"/>
              <a:t>24/06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17CB45E-0B6F-894A-8ED4-E6D5A2DFED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0B6B696-6C08-8743-AA5D-B8A955F08D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ADFBF-D4B4-234E-83BE-E50A8B9AF2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0407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A49C6CA4-C507-B647-A2ED-50293E85FE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5091" y="886647"/>
            <a:ext cx="7370293" cy="1418977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EF68AD0C-B1F5-1B40-A8AD-A0DF35896A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0390" y="2895950"/>
            <a:ext cx="9039840" cy="1720447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2653FE7D-BADF-D448-B05C-71353B1EA351}"/>
              </a:ext>
            </a:extLst>
          </p:cNvPr>
          <p:cNvSpPr txBox="1"/>
          <p:nvPr/>
        </p:nvSpPr>
        <p:spPr>
          <a:xfrm>
            <a:off x="859277" y="886647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AFC0FCB-34D9-7943-B9A3-2F95738CBD85}"/>
              </a:ext>
            </a:extLst>
          </p:cNvPr>
          <p:cNvSpPr txBox="1"/>
          <p:nvPr/>
        </p:nvSpPr>
        <p:spPr>
          <a:xfrm>
            <a:off x="828797" y="252661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36EC338-37C6-9D43-A9B6-4D756A8EF846}"/>
              </a:ext>
            </a:extLst>
          </p:cNvPr>
          <p:cNvSpPr/>
          <p:nvPr/>
        </p:nvSpPr>
        <p:spPr>
          <a:xfrm>
            <a:off x="828797" y="4852780"/>
            <a:ext cx="11057107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000" b="1" dirty="0">
                <a:solidFill>
                  <a:srgbClr val="000000"/>
                </a:solidFill>
                <a:latin typeface="Times" pitchFamily="2" charset="0"/>
                <a:ea typeface="Times New Roman" panose="02020603050405020304" pitchFamily="18" charset="0"/>
              </a:rPr>
              <a:t>S1 Fig. Experimental timelines of </a:t>
            </a:r>
            <a:r>
              <a:rPr lang="en-GB" sz="1000" b="1" i="1" dirty="0">
                <a:solidFill>
                  <a:srgbClr val="000000"/>
                </a:solidFill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b="1" dirty="0">
                <a:solidFill>
                  <a:srgbClr val="000000"/>
                </a:solidFill>
                <a:latin typeface="Times" pitchFamily="2" charset="0"/>
                <a:ea typeface="Times New Roman" panose="02020603050405020304" pitchFamily="18" charset="0"/>
              </a:rPr>
              <a:t> silencing in the constitutive and inducible models.</a:t>
            </a:r>
            <a:r>
              <a:rPr lang="fr-BE" sz="1000" b="1" i="1" dirty="0">
                <a:solidFill>
                  <a:srgbClr val="1F497D"/>
                </a:solidFill>
                <a:latin typeface="Times" pitchFamily="2" charset="0"/>
                <a:ea typeface="Times New Roman" panose="02020603050405020304" pitchFamily="18" charset="0"/>
              </a:rPr>
              <a:t> 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Cells were transduced and puromycin-selected with a vector allowing a constitutive (a) or an inducible (b) </a:t>
            </a:r>
            <a:r>
              <a:rPr lang="en-GB" sz="1000" i="1" dirty="0"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 silencing. After 2 days of recovery, cells were either seeded and allowed to grow for 4 days before assessment of proliferation (a) or treated with 0.1 mM of IsoPropyl ß-D-1-ThioGalactopyranoside (IPTG) for 5 days to induce </a:t>
            </a:r>
            <a:r>
              <a:rPr lang="en-GB" sz="1000" i="1" dirty="0"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 silencing prior to the seeding (b). The proliferation was then assessed after 4 days of growth in presence of IPTG renewed daily.</a:t>
            </a:r>
            <a:endParaRPr lang="fr-BE" sz="1000" dirty="0">
              <a:effectLst/>
              <a:latin typeface="Times" pitchFamily="2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98180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06</Words>
  <Application>Microsoft Macintosh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11</cp:revision>
  <dcterms:created xsi:type="dcterms:W3CDTF">2019-03-06T14:53:16Z</dcterms:created>
  <dcterms:modified xsi:type="dcterms:W3CDTF">2019-06-24T14:14:02Z</dcterms:modified>
</cp:coreProperties>
</file>